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5ECC4C-2D48-4D80-BAA8-2CD17CFD1E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DCAF7-FD7E-4497-9EE9-A330ECD0D3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D8466-5A0F-4D03-9A3C-1A5A600559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BC900-C0A2-4172-85AF-D91BE16B56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03326E-5941-4822-94F8-0547D07DAB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EE771-2704-4E0F-83B7-B387CD058A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9FB6AC-5C79-4D46-8945-5E8C8441CA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D7485-C7A5-49B3-B1B1-5B1618EF4D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116C9-2E31-44C2-9C27-226B356E3A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BA2E0-64A7-4D71-8AD3-B21625552A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65E322-8DBE-4844-BC2F-DC78D2E32B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04913-BAD5-4B6D-87E6-53FC5E88E5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F149FE3-DFC8-47C4-BC8C-990DF825C346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80F4460-6A4D-4261-ABAD-8B8EEA02883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4"/>
          <p:cNvSpPr/>
          <p:nvPr/>
        </p:nvSpPr>
        <p:spPr>
          <a:xfrm rot="18900000">
            <a:off x="1662480" y="1375200"/>
            <a:ext cx="127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T47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12"/>
          <p:cNvSpPr/>
          <p:nvPr/>
        </p:nvSpPr>
        <p:spPr>
          <a:xfrm rot="18900000">
            <a:off x="1218240" y="1371600"/>
            <a:ext cx="109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DA-2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13"/>
          <p:cNvSpPr/>
          <p:nvPr/>
        </p:nvSpPr>
        <p:spPr>
          <a:xfrm rot="18900000">
            <a:off x="1536840" y="1484280"/>
            <a:ext cx="78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15"/>
          <p:cNvSpPr/>
          <p:nvPr/>
        </p:nvSpPr>
        <p:spPr>
          <a:xfrm rot="18900000">
            <a:off x="1994040" y="1371960"/>
            <a:ext cx="108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DA-46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22"/>
          <p:cNvSpPr/>
          <p:nvPr/>
        </p:nvSpPr>
        <p:spPr>
          <a:xfrm>
            <a:off x="2625840" y="2173320"/>
            <a:ext cx="455400" cy="28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44"/>
          <p:cNvSpPr/>
          <p:nvPr/>
        </p:nvSpPr>
        <p:spPr>
          <a:xfrm>
            <a:off x="2723400" y="20145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Src41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45"/>
          <p:cNvSpPr/>
          <p:nvPr/>
        </p:nvSpPr>
        <p:spPr>
          <a:xfrm>
            <a:off x="2724120" y="2462040"/>
            <a:ext cx="44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-ki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46"/>
          <p:cNvSpPr/>
          <p:nvPr/>
        </p:nvSpPr>
        <p:spPr>
          <a:xfrm>
            <a:off x="2755800" y="2909880"/>
            <a:ext cx="633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APD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47"/>
          <p:cNvSpPr/>
          <p:nvPr/>
        </p:nvSpPr>
        <p:spPr>
          <a:xfrm rot="18900000">
            <a:off x="2275200" y="1371960"/>
            <a:ext cx="108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KBR-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11" descr="3-18-08-Panel-pSrc, ckit, Gapdh-crop.psd"/>
          <p:cNvPicPr/>
          <p:nvPr/>
        </p:nvPicPr>
        <p:blipFill>
          <a:blip r:embed="rId1"/>
          <a:stretch/>
        </p:blipFill>
        <p:spPr>
          <a:xfrm>
            <a:off x="1236600" y="1903320"/>
            <a:ext cx="1513080" cy="1360440"/>
          </a:xfrm>
          <a:prstGeom prst="rect">
            <a:avLst/>
          </a:prstGeom>
          <a:ln w="0">
            <a:noFill/>
          </a:ln>
        </p:spPr>
      </p:pic>
      <p:sp>
        <p:nvSpPr>
          <p:cNvPr id="51" name="Rectangle 2"/>
          <p:cNvSpPr/>
          <p:nvPr/>
        </p:nvSpPr>
        <p:spPr>
          <a:xfrm>
            <a:off x="228600" y="0"/>
            <a:ext cx="2743200" cy="6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600" spc="-1" strike="noStrike">
                <a:solidFill>
                  <a:srgbClr val="1f497d"/>
                </a:solidFill>
                <a:latin typeface="Calibri"/>
              </a:rPr>
              <a:t>Pichot et al</a:t>
            </a:r>
            <a:br>
              <a:rPr sz="1600"/>
            </a:br>
            <a:r>
              <a:rPr b="0" i="1" lang="en-US" sz="1600" spc="-1" strike="noStrike">
                <a:solidFill>
                  <a:srgbClr val="1f497d"/>
                </a:solidFill>
                <a:latin typeface="Calibri"/>
              </a:rPr>
              <a:t>Supplemental Figure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" name="Group 30"/>
          <p:cNvGrpSpPr/>
          <p:nvPr/>
        </p:nvGrpSpPr>
        <p:grpSpPr>
          <a:xfrm>
            <a:off x="4843440" y="2971800"/>
            <a:ext cx="3083040" cy="1430280"/>
            <a:chOff x="4843440" y="2971800"/>
            <a:chExt cx="3083040" cy="1430280"/>
          </a:xfrm>
        </p:grpSpPr>
        <p:pic>
          <p:nvPicPr>
            <p:cNvPr id="53" name="Picture 113" descr="3-18-08-MDA-468-pSrc-crop"/>
            <p:cNvPicPr/>
            <p:nvPr/>
          </p:nvPicPr>
          <p:blipFill>
            <a:blip r:embed="rId2"/>
            <a:stretch/>
          </p:blipFill>
          <p:spPr>
            <a:xfrm>
              <a:off x="5015520" y="3709440"/>
              <a:ext cx="2178360" cy="692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 Box 7"/>
            <p:cNvSpPr/>
            <p:nvPr/>
          </p:nvSpPr>
          <p:spPr>
            <a:xfrm>
              <a:off x="7174080" y="3709440"/>
              <a:ext cx="752400" cy="550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pSrc-Y41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Calibri"/>
                </a:rPr>
                <a:t>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Src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 Box 92"/>
            <p:cNvSpPr/>
            <p:nvPr/>
          </p:nvSpPr>
          <p:spPr>
            <a:xfrm>
              <a:off x="4843440" y="2971800"/>
              <a:ext cx="1047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MDA-MB-46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 Box 43"/>
            <p:cNvSpPr/>
            <p:nvPr/>
          </p:nvSpPr>
          <p:spPr>
            <a:xfrm rot="18106800">
              <a:off x="5018400" y="3373200"/>
              <a:ext cx="5450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DMSO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 Box 44"/>
            <p:cNvSpPr/>
            <p:nvPr/>
          </p:nvSpPr>
          <p:spPr>
            <a:xfrm rot="18498600">
              <a:off x="5344560" y="350028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 Box 45"/>
            <p:cNvSpPr/>
            <p:nvPr/>
          </p:nvSpPr>
          <p:spPr>
            <a:xfrm rot="18498600">
              <a:off x="5594040" y="3477960"/>
              <a:ext cx="37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 Box 46"/>
            <p:cNvSpPr/>
            <p:nvPr/>
          </p:nvSpPr>
          <p:spPr>
            <a:xfrm rot="18498600">
              <a:off x="5842440" y="349668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 Box 47"/>
            <p:cNvSpPr/>
            <p:nvPr/>
          </p:nvSpPr>
          <p:spPr>
            <a:xfrm rot="18498600">
              <a:off x="6051240" y="3477960"/>
              <a:ext cx="372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 Box 48"/>
            <p:cNvSpPr/>
            <p:nvPr/>
          </p:nvSpPr>
          <p:spPr>
            <a:xfrm rot="18498600">
              <a:off x="6563880" y="350028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 Box 49"/>
            <p:cNvSpPr/>
            <p:nvPr/>
          </p:nvSpPr>
          <p:spPr>
            <a:xfrm rot="18498600">
              <a:off x="6326640" y="35384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 Box 50"/>
            <p:cNvSpPr/>
            <p:nvPr/>
          </p:nvSpPr>
          <p:spPr>
            <a:xfrm rot="18498600">
              <a:off x="6768360" y="3442320"/>
              <a:ext cx="407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100</a:t>
              </a: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 Box 51"/>
            <p:cNvSpPr/>
            <p:nvPr/>
          </p:nvSpPr>
          <p:spPr>
            <a:xfrm>
              <a:off x="5379120" y="3252240"/>
              <a:ext cx="456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Das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 Box 52"/>
            <p:cNvSpPr/>
            <p:nvPr/>
          </p:nvSpPr>
          <p:spPr>
            <a:xfrm>
              <a:off x="5825520" y="3252240"/>
              <a:ext cx="478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Doxo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 Box 53"/>
            <p:cNvSpPr/>
            <p:nvPr/>
          </p:nvSpPr>
          <p:spPr>
            <a:xfrm>
              <a:off x="6472800" y="3252240"/>
              <a:ext cx="10357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Combo   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                  </a:t>
              </a:r>
              <a:r>
                <a:rPr b="0" lang="en-US" sz="1100" spc="-1" strike="noStrike">
                  <a:solidFill>
                    <a:srgbClr val="000000"/>
                  </a:solidFill>
                  <a:latin typeface="Calibri"/>
                </a:rPr>
                <a:t>(nM)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Straight Connector 27"/>
            <p:cNvSpPr/>
            <p:nvPr/>
          </p:nvSpPr>
          <p:spPr>
            <a:xfrm>
              <a:off x="6419880" y="3480840"/>
              <a:ext cx="609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Straight Connector 28"/>
            <p:cNvSpPr/>
            <p:nvPr/>
          </p:nvSpPr>
          <p:spPr>
            <a:xfrm>
              <a:off x="5886360" y="3480840"/>
              <a:ext cx="3808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Straight Connector 29"/>
            <p:cNvSpPr/>
            <p:nvPr/>
          </p:nvSpPr>
          <p:spPr>
            <a:xfrm>
              <a:off x="5352840" y="3480840"/>
              <a:ext cx="4572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0" name="Chart 31" descr=""/>
          <p:cNvPicPr/>
          <p:nvPr/>
        </p:nvPicPr>
        <p:blipFill>
          <a:blip r:embed="rId3"/>
          <a:stretch/>
        </p:blipFill>
        <p:spPr>
          <a:xfrm>
            <a:off x="4797360" y="225360"/>
            <a:ext cx="3359160" cy="2676600"/>
          </a:xfrm>
          <a:prstGeom prst="rect">
            <a:avLst/>
          </a:prstGeom>
          <a:ln w="0">
            <a:noFill/>
          </a:ln>
        </p:spPr>
      </p:pic>
      <p:sp>
        <p:nvSpPr>
          <p:cNvPr id="71" name="TextBox 32"/>
          <p:cNvSpPr/>
          <p:nvPr/>
        </p:nvSpPr>
        <p:spPr>
          <a:xfrm>
            <a:off x="7227000" y="685800"/>
            <a:ext cx="1192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C50=17.8 μM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3"/>
          <p:cNvSpPr/>
          <p:nvPr/>
        </p:nvSpPr>
        <p:spPr>
          <a:xfrm>
            <a:off x="457200" y="4876920"/>
            <a:ext cx="792468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ure 1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Whole cell lysates were collected from a panel of untreated breast cancer cell lines and western blotted for basal levels of phospho-Src and c-kit. The membrane was stripped and reprobed for GAPDH as a loading control.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MDA-MB-468 cells were grown in 96-well plates with complete medium, then treated with dasatinib for 48 hours before analysis by MTT assay. Results are shown as a percent of DMSO-treated samples and represent the mean of 2 independent assays with 4-5 replicates each. Error bars are standard error of the mean (SEM).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, Protein lysates of MDA-MB-468 cells treated for 2 hours were immunoblotted for pSrc-Y416, stripped and reprobed for total Src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12"/>
          <p:cNvSpPr/>
          <p:nvPr/>
        </p:nvSpPr>
        <p:spPr>
          <a:xfrm>
            <a:off x="4364640" y="3048120"/>
            <a:ext cx="28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 Box 12"/>
          <p:cNvSpPr/>
          <p:nvPr/>
        </p:nvSpPr>
        <p:spPr>
          <a:xfrm>
            <a:off x="4343400" y="380880"/>
            <a:ext cx="30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12"/>
          <p:cNvSpPr/>
          <p:nvPr/>
        </p:nvSpPr>
        <p:spPr>
          <a:xfrm>
            <a:off x="928800" y="144792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30T16:20:04Z</dcterms:created>
  <dc:creator>Chrissy Pichot</dc:creator>
  <dc:description/>
  <dc:language>en-US</dc:language>
  <cp:lastModifiedBy>Chrissy Pichot</cp:lastModifiedBy>
  <dcterms:modified xsi:type="dcterms:W3CDTF">2009-04-30T16:26:06Z</dcterms:modified>
  <cp:revision>2</cp:revision>
  <dc:subject/>
  <dc:title>Slide 1</dc:title>
</cp:coreProperties>
</file>